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305" r:id="rId2"/>
    <p:sldId id="306" r:id="rId3"/>
    <p:sldId id="307" r:id="rId4"/>
    <p:sldId id="291" r:id="rId5"/>
    <p:sldId id="308" r:id="rId6"/>
    <p:sldId id="309" r:id="rId7"/>
    <p:sldId id="310" r:id="rId8"/>
    <p:sldId id="311" r:id="rId9"/>
    <p:sldId id="312" r:id="rId10"/>
    <p:sldId id="313" r:id="rId11"/>
    <p:sldId id="314" r:id="rId12"/>
    <p:sldId id="315" r:id="rId13"/>
    <p:sldId id="316" r:id="rId1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82" d="100"/>
          <a:sy n="82" d="100"/>
        </p:scale>
        <p:origin x="29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A18702-9389-49B4-AF99-F1F33E96B8A5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8E1186-93C3-4DED-BE8A-14B58A2577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4922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EF30D1-8939-4E21-9420-737B283ED13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92584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EF30D1-8939-4E21-9420-737B283ED135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5909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EF30D1-8939-4E21-9420-737B283ED135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36069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7964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0931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835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3567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233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123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812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9753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7395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3187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931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14BFE5-35B5-4BCA-9381-27EF31143F8A}" type="datetimeFigureOut">
              <a:rPr lang="en-GB" smtClean="0"/>
              <a:t>24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41F842-2712-4C8C-A931-D0E76A4EDA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2233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88927D3-D8D0-E769-10A9-929E07B7FF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136374" y="3233958"/>
            <a:ext cx="9130748" cy="4213336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7E9B87F-32AD-954F-BD3B-11D957992598}"/>
              </a:ext>
            </a:extLst>
          </p:cNvPr>
          <p:cNvSpPr txBox="1"/>
          <p:nvPr/>
        </p:nvSpPr>
        <p:spPr>
          <a:xfrm>
            <a:off x="367748" y="298174"/>
            <a:ext cx="6370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1: Normalised microsatellite allele lengths and frequencies for case 1.1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1109012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080E554-5106-7C31-A389-78D8EC276E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207882" y="3007445"/>
            <a:ext cx="9273763" cy="4279568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3BE1A97-3D31-A8BD-0930-15A3294BB8E3}"/>
              </a:ext>
            </a:extLst>
          </p:cNvPr>
          <p:cNvSpPr txBox="1"/>
          <p:nvPr/>
        </p:nvSpPr>
        <p:spPr>
          <a:xfrm>
            <a:off x="238539" y="113882"/>
            <a:ext cx="65300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9: Normalised microsatellite allele lengths and frequencies for case 2.5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29100281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61E2722-D625-9A3B-6AB5-CC36C772A7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331583" y="2509725"/>
            <a:ext cx="9521166" cy="5271383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70EE2D5-0DD8-06E8-AA3A-B0F8B31E8D3D}"/>
              </a:ext>
            </a:extLst>
          </p:cNvPr>
          <p:cNvSpPr txBox="1"/>
          <p:nvPr/>
        </p:nvSpPr>
        <p:spPr>
          <a:xfrm>
            <a:off x="238539" y="113882"/>
            <a:ext cx="65300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10: Normalised microsatellite allele lengths and frequencies for case A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7394612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BD4CA8-C01A-7DEE-0291-BBCB355041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486386"/>
          </a:xfrm>
        </p:spPr>
        <p:txBody>
          <a:bodyPr>
            <a:normAutofit/>
          </a:bodyPr>
          <a:lstStyle/>
          <a:p>
            <a:r>
              <a:rPr lang="en-GB" sz="1200" kern="100" dirty="0">
                <a:effectLst/>
                <a:latin typeface="+mn-lt"/>
                <a:ea typeface="Aptos" panose="020B0004020202020204" pitchFamily="34" charset="0"/>
                <a:cs typeface="Times New Roman" panose="02020603050405020304" pitchFamily="18" charset="0"/>
              </a:rPr>
              <a:t>Supplementary Figure 11: Initial and 12 month repeat analyses for </a:t>
            </a:r>
            <a:r>
              <a:rPr lang="en-GB" sz="1200" i="1" kern="100" dirty="0">
                <a:effectLst/>
                <a:latin typeface="+mn-lt"/>
                <a:ea typeface="Aptos" panose="020B0004020202020204" pitchFamily="34" charset="0"/>
                <a:cs typeface="Times New Roman" panose="02020603050405020304" pitchFamily="18" charset="0"/>
              </a:rPr>
              <a:t>MSH2</a:t>
            </a:r>
            <a:r>
              <a:rPr lang="en-GB" sz="1200" kern="100" dirty="0">
                <a:effectLst/>
                <a:latin typeface="+mn-lt"/>
                <a:ea typeface="Aptos" panose="020B0004020202020204" pitchFamily="34" charset="0"/>
                <a:cs typeface="Times New Roman" panose="02020603050405020304" pitchFamily="18" charset="0"/>
              </a:rPr>
              <a:t>-LS carriers without a urothelial cancer diagnosis</a:t>
            </a:r>
            <a:endParaRPr lang="en-GB" sz="1200" dirty="0">
              <a:latin typeface="+mn-lt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5F4953E-70CC-2F1A-8069-AB8B9AC633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113" y="1351721"/>
            <a:ext cx="6114400" cy="4129391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80668275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AF6DCD36-5F4B-603D-6F9C-8F09BA89BF57}"/>
              </a:ext>
            </a:extLst>
          </p:cNvPr>
          <p:cNvSpPr txBox="1">
            <a:spLocks/>
          </p:cNvSpPr>
          <p:nvPr/>
        </p:nvSpPr>
        <p:spPr>
          <a:xfrm>
            <a:off x="471488" y="527405"/>
            <a:ext cx="5915025" cy="4863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 kern="100" dirty="0">
                <a:latin typeface="+mn-lt"/>
                <a:ea typeface="Aptos" panose="020B0004020202020204" pitchFamily="34" charset="0"/>
                <a:cs typeface="Times New Roman" panose="02020603050405020304" pitchFamily="18" charset="0"/>
              </a:rPr>
              <a:t>Supplementary Figure 12: ROC plot for cohort 2</a:t>
            </a:r>
            <a:endParaRPr lang="en-GB" sz="1200" dirty="0">
              <a:latin typeface="+mn-lt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C18B7E2-8202-3964-2590-0885F02472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8296" y="1133060"/>
            <a:ext cx="5917096" cy="5917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28947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59029F7-36D6-6A37-B355-CC0C4F1ECD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137147" y="3656403"/>
            <a:ext cx="9132294" cy="3366899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FC29EA0-ED67-4A8C-1865-848368AF743C}"/>
              </a:ext>
            </a:extLst>
          </p:cNvPr>
          <p:cNvSpPr txBox="1"/>
          <p:nvPr/>
        </p:nvSpPr>
        <p:spPr>
          <a:xfrm>
            <a:off x="367748" y="298174"/>
            <a:ext cx="6370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2: Normalised microsatellite allele lengths and frequencies for case 1.2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316001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graph&#10;&#10;AI-generated content may be incorrect.">
            <a:extLst>
              <a:ext uri="{FF2B5EF4-FFF2-40B4-BE49-F238E27FC236}">
                <a16:creationId xmlns:a16="http://schemas.microsoft.com/office/drawing/2014/main" id="{47430465-06DA-D87E-F144-F16614F79A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312925" y="3415578"/>
            <a:ext cx="9483850" cy="3496993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3612428-0986-D40E-5920-A9DC6962953B}"/>
              </a:ext>
            </a:extLst>
          </p:cNvPr>
          <p:cNvSpPr txBox="1"/>
          <p:nvPr/>
        </p:nvSpPr>
        <p:spPr>
          <a:xfrm>
            <a:off x="377687" y="119270"/>
            <a:ext cx="6370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3: Normalised microsatellite allele lengths and frequencies for case 1.3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339814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1D311CF-7A72-9F39-5FE2-FF54180AA9A1}"/>
              </a:ext>
            </a:extLst>
          </p:cNvPr>
          <p:cNvSpPr txBox="1"/>
          <p:nvPr/>
        </p:nvSpPr>
        <p:spPr>
          <a:xfrm>
            <a:off x="126938" y="207415"/>
            <a:ext cx="15478125" cy="32419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132080" tIns="66041" rIns="132080" bIns="66041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>
              <a:lnSpc>
                <a:spcPct val="107000"/>
              </a:lnSpc>
              <a:spcAft>
                <a:spcPts val="1156"/>
              </a:spcAft>
            </a:pPr>
            <a:r>
              <a:rPr lang="en-GB" sz="1200" kern="100" dirty="0">
                <a:ea typeface="Aptos" panose="020B0004020202020204" pitchFamily="34" charset="0"/>
                <a:cs typeface="Times New Roman" panose="02020603050405020304" pitchFamily="18" charset="0"/>
              </a:rPr>
              <a:t>Supplementary Figure 4: ROC plot for cohort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5781D43-F6EF-4A28-3917-52CD0AB920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394" y="646657"/>
            <a:ext cx="5875166" cy="58751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32016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graph&#10;&#10;AI-generated content may be incorrect.">
            <a:extLst>
              <a:ext uri="{FF2B5EF4-FFF2-40B4-BE49-F238E27FC236}">
                <a16:creationId xmlns:a16="http://schemas.microsoft.com/office/drawing/2014/main" id="{A4674916-8B51-8D83-B1E9-84E519C9483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1107390" y="2857419"/>
            <a:ext cx="9072781" cy="502438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8A26F37-EE4E-A749-007C-3C08ADF43A00}"/>
              </a:ext>
            </a:extLst>
          </p:cNvPr>
          <p:cNvSpPr txBox="1"/>
          <p:nvPr/>
        </p:nvSpPr>
        <p:spPr>
          <a:xfrm>
            <a:off x="367748" y="298174"/>
            <a:ext cx="6370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5: Normalised microsatellite allele lengths and frequencies for case 2.1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5128304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8BD0C84-7A58-E917-B82C-F0509DF48B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065081" y="2509585"/>
            <a:ext cx="8988162" cy="5804668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3B14FCD-CB40-B91B-475B-8DD38AD7629D}"/>
              </a:ext>
            </a:extLst>
          </p:cNvPr>
          <p:cNvSpPr txBox="1"/>
          <p:nvPr/>
        </p:nvSpPr>
        <p:spPr>
          <a:xfrm>
            <a:off x="367748" y="298174"/>
            <a:ext cx="6370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6: Normalised microsatellite allele lengths and frequencies for case 2.2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5832034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00141DF-3C2B-38EE-7AA9-8DB2ADA002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245318" y="3508012"/>
            <a:ext cx="9348636" cy="3447339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294C6DD-33D9-027B-13BA-A3B2F3E7A235}"/>
              </a:ext>
            </a:extLst>
          </p:cNvPr>
          <p:cNvSpPr txBox="1"/>
          <p:nvPr/>
        </p:nvSpPr>
        <p:spPr>
          <a:xfrm>
            <a:off x="367748" y="298174"/>
            <a:ext cx="6370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7: Normalised microsatellite allele lengths and frequencies for case 2.3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6510141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684DADE-5A65-E985-DADA-7E53EE6947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1250673" y="2634727"/>
            <a:ext cx="9359346" cy="51832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CFD9E6F-DF59-2650-982C-F8E49596607E}"/>
              </a:ext>
            </a:extLst>
          </p:cNvPr>
          <p:cNvSpPr txBox="1"/>
          <p:nvPr/>
        </p:nvSpPr>
        <p:spPr>
          <a:xfrm>
            <a:off x="367747" y="298174"/>
            <a:ext cx="66790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8A: Normalised microsatellite allele lengths and frequencies for case 2.4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9312644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3AC69B7-0EF5-46A0-8D1C-807856A9E91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6891C53-6138-710F-8181-F853E93157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305475" y="2550217"/>
            <a:ext cx="9468951" cy="5242615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69093F3-1178-90CE-8689-9EE58EBF806C}"/>
              </a:ext>
            </a:extLst>
          </p:cNvPr>
          <p:cNvSpPr txBox="1"/>
          <p:nvPr/>
        </p:nvSpPr>
        <p:spPr>
          <a:xfrm>
            <a:off x="238539" y="113882"/>
            <a:ext cx="65300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Supplementary Figure 8B: Normalised microsatellite allele lengths and frequencies for case 2.4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812613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</TotalTime>
  <Words>169</Words>
  <Application>Microsoft Office PowerPoint</Application>
  <PresentationFormat>A4 Paper (210x297 mm)</PresentationFormat>
  <Paragraphs>16</Paragraphs>
  <Slides>1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ry Figure 11: Initial and 12 month repeat analyses for MSH2-LS carriers without a urothelial cancer diagnosis</vt:lpstr>
      <vt:lpstr>PowerPoint Presentation</vt:lpstr>
    </vt:vector>
  </TitlesOfParts>
  <Company>Newcastle Upon Tyne Hospital Tru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L, Rebecca (THE NEWCASTLE UPON TYNE HOSPITALS NHS FOUNDATION TRUST)</dc:creator>
  <cp:lastModifiedBy>Rebecca Hall</cp:lastModifiedBy>
  <cp:revision>2</cp:revision>
  <dcterms:created xsi:type="dcterms:W3CDTF">2025-07-22T13:25:34Z</dcterms:created>
  <dcterms:modified xsi:type="dcterms:W3CDTF">2025-07-24T11:35:58Z</dcterms:modified>
</cp:coreProperties>
</file>